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charts/chart1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072" autoAdjust="0"/>
    <p:restoredTop sz="94660"/>
  </p:normalViewPr>
  <p:slideViewPr>
    <p:cSldViewPr snapToGrid="0">
      <p:cViewPr varScale="1">
        <p:scale>
          <a:sx n="65" d="100"/>
          <a:sy n="65" d="100"/>
        </p:scale>
        <p:origin x="11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charts/_rels/chart1.xml.rels><?xml version = '1.0' encoding = 'UTF-8' standalone = 'yes'?>
<Relationships xmlns="http://schemas.openxmlformats.org/package/2006/relationships">
   <Relationship Id="rId1" Type="http://schemas.microsoft.com/office/2011/relationships/chartStyle" Target="style1.xml"/>
   <Relationship Id="rId2" Type="http://schemas.microsoft.com/office/2011/relationships/chartColorStyle" Target="colors1.xml"/>
   <Relationship Id="rId3" Type="http://schemas.openxmlformats.org/officeDocument/2006/relationships/package" Target="../embeddings/Microsoft_Excel_Worksheet1.xlsx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graph for publication'!$C$106</c:f>
              <c:strCache>
                <c:ptCount val="1"/>
                <c:pt idx="0">
                  <c:v>Astaxanthin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graph for publication'!$D$105:$H$105</c:f>
              <c:strCache>
                <c:ptCount val="5"/>
                <c:pt idx="0">
                  <c:v>p-Ø</c:v>
                </c:pt>
                <c:pt idx="1">
                  <c:v>pZ+W</c:v>
                </c:pt>
                <c:pt idx="2">
                  <c:v>pZ-s-W</c:v>
                </c:pt>
                <c:pt idx="3">
                  <c:v>pZ-m-W</c:v>
                </c:pt>
                <c:pt idx="4">
                  <c:v>pZ-lg-W</c:v>
                </c:pt>
              </c:strCache>
            </c:strRef>
          </c:cat>
          <c:val>
            <c:numRef>
              <c:f>'graph for publication'!$D$106:$H$106</c:f>
              <c:numCache>
                <c:formatCode>General</c:formatCode>
                <c:ptCount val="5"/>
                <c:pt idx="0">
                  <c:v>0</c:v>
                </c:pt>
                <c:pt idx="1">
                  <c:v>17.728905246014563</c:v>
                </c:pt>
                <c:pt idx="2">
                  <c:v>14.197091629880417</c:v>
                </c:pt>
                <c:pt idx="3">
                  <c:v>11.594006750192833</c:v>
                </c:pt>
                <c:pt idx="4">
                  <c:v>6.3581075706649557</c:v>
                </c:pt>
              </c:numCache>
            </c:numRef>
          </c:val>
        </c:ser>
        <c:ser>
          <c:idx val="1"/>
          <c:order val="1"/>
          <c:tx>
            <c:strRef>
              <c:f>'graph for publication'!$C$107</c:f>
              <c:strCache>
                <c:ptCount val="1"/>
                <c:pt idx="0">
                  <c:v>Adonixanthin</c:v>
                </c:pt>
              </c:strCache>
            </c:strRef>
          </c:tx>
          <c:spPr>
            <a:solidFill>
              <a:schemeClr val="accent5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graph for publication'!$D$105:$H$105</c:f>
              <c:strCache>
                <c:ptCount val="5"/>
                <c:pt idx="0">
                  <c:v>p-Ø</c:v>
                </c:pt>
                <c:pt idx="1">
                  <c:v>pZ+W</c:v>
                </c:pt>
                <c:pt idx="2">
                  <c:v>pZ-s-W</c:v>
                </c:pt>
                <c:pt idx="3">
                  <c:v>pZ-m-W</c:v>
                </c:pt>
                <c:pt idx="4">
                  <c:v>pZ-lg-W</c:v>
                </c:pt>
              </c:strCache>
            </c:strRef>
          </c:cat>
          <c:val>
            <c:numRef>
              <c:f>'graph for publication'!$D$107:$H$107</c:f>
              <c:numCache>
                <c:formatCode>General</c:formatCode>
                <c:ptCount val="5"/>
                <c:pt idx="0">
                  <c:v>0</c:v>
                </c:pt>
                <c:pt idx="1">
                  <c:v>21.226527130120758</c:v>
                </c:pt>
                <c:pt idx="2">
                  <c:v>18.112233159637302</c:v>
                </c:pt>
                <c:pt idx="3">
                  <c:v>25.216608245755356</c:v>
                </c:pt>
                <c:pt idx="4">
                  <c:v>14.560460035219078</c:v>
                </c:pt>
              </c:numCache>
            </c:numRef>
          </c:val>
        </c:ser>
        <c:ser>
          <c:idx val="2"/>
          <c:order val="2"/>
          <c:tx>
            <c:strRef>
              <c:f>'graph for publication'!$C$108</c:f>
              <c:strCache>
                <c:ptCount val="1"/>
                <c:pt idx="0">
                  <c:v>Phoenicoxanthin</c:v>
                </c:pt>
              </c:strCache>
            </c:strRef>
          </c:tx>
          <c:spPr>
            <a:solidFill>
              <a:schemeClr val="tx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graph for publication'!$D$105:$H$105</c:f>
              <c:strCache>
                <c:ptCount val="5"/>
                <c:pt idx="0">
                  <c:v>p-Ø</c:v>
                </c:pt>
                <c:pt idx="1">
                  <c:v>pZ+W</c:v>
                </c:pt>
                <c:pt idx="2">
                  <c:v>pZ-s-W</c:v>
                </c:pt>
                <c:pt idx="3">
                  <c:v>pZ-m-W</c:v>
                </c:pt>
                <c:pt idx="4">
                  <c:v>pZ-lg-W</c:v>
                </c:pt>
              </c:strCache>
            </c:strRef>
          </c:cat>
          <c:val>
            <c:numRef>
              <c:f>'graph for publication'!$D$108:$H$108</c:f>
              <c:numCache>
                <c:formatCode>General</c:formatCode>
                <c:ptCount val="5"/>
                <c:pt idx="0">
                  <c:v>0</c:v>
                </c:pt>
                <c:pt idx="1">
                  <c:v>41.336636827124195</c:v>
                </c:pt>
                <c:pt idx="2">
                  <c:v>12.933827486783402</c:v>
                </c:pt>
                <c:pt idx="3">
                  <c:v>9.82294700490141</c:v>
                </c:pt>
                <c:pt idx="4">
                  <c:v>9.0802374475094378</c:v>
                </c:pt>
              </c:numCache>
            </c:numRef>
          </c:val>
        </c:ser>
        <c:ser>
          <c:idx val="3"/>
          <c:order val="3"/>
          <c:tx>
            <c:strRef>
              <c:f>'graph for publication'!$C$109</c:f>
              <c:strCache>
                <c:ptCount val="1"/>
                <c:pt idx="0">
                  <c:v>Canthaxanthin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graph for publication'!$D$105:$H$105</c:f>
              <c:strCache>
                <c:ptCount val="5"/>
                <c:pt idx="0">
                  <c:v>p-Ø</c:v>
                </c:pt>
                <c:pt idx="1">
                  <c:v>pZ+W</c:v>
                </c:pt>
                <c:pt idx="2">
                  <c:v>pZ-s-W</c:v>
                </c:pt>
                <c:pt idx="3">
                  <c:v>pZ-m-W</c:v>
                </c:pt>
                <c:pt idx="4">
                  <c:v>pZ-lg-W</c:v>
                </c:pt>
              </c:strCache>
            </c:strRef>
          </c:cat>
          <c:val>
            <c:numRef>
              <c:f>'graph for publication'!$D$109:$H$109</c:f>
              <c:numCache>
                <c:formatCode>General</c:formatCode>
                <c:ptCount val="5"/>
                <c:pt idx="0">
                  <c:v>0</c:v>
                </c:pt>
                <c:pt idx="1">
                  <c:v>167.49015835060075</c:v>
                </c:pt>
                <c:pt idx="2">
                  <c:v>9.6986057145757698</c:v>
                </c:pt>
                <c:pt idx="3">
                  <c:v>9.9395276879651551</c:v>
                </c:pt>
                <c:pt idx="4">
                  <c:v>3.4840822056208438</c:v>
                </c:pt>
              </c:numCache>
            </c:numRef>
          </c:val>
        </c:ser>
        <c:ser>
          <c:idx val="4"/>
          <c:order val="4"/>
          <c:tx>
            <c:strRef>
              <c:f>'graph for publication'!$C$110</c:f>
              <c:strCache>
                <c:ptCount val="1"/>
                <c:pt idx="0">
                  <c:v>3'OH-Echinenone &amp; isomers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graph for publication'!$D$105:$H$105</c:f>
              <c:strCache>
                <c:ptCount val="5"/>
                <c:pt idx="0">
                  <c:v>p-Ø</c:v>
                </c:pt>
                <c:pt idx="1">
                  <c:v>pZ+W</c:v>
                </c:pt>
                <c:pt idx="2">
                  <c:v>pZ-s-W</c:v>
                </c:pt>
                <c:pt idx="3">
                  <c:v>pZ-m-W</c:v>
                </c:pt>
                <c:pt idx="4">
                  <c:v>pZ-lg-W</c:v>
                </c:pt>
              </c:strCache>
            </c:strRef>
          </c:cat>
          <c:val>
            <c:numRef>
              <c:f>'graph for publication'!$D$110:$H$110</c:f>
              <c:numCache>
                <c:formatCode>General</c:formatCode>
                <c:ptCount val="5"/>
                <c:pt idx="0">
                  <c:v>0</c:v>
                </c:pt>
                <c:pt idx="1">
                  <c:v>61.561446159590886</c:v>
                </c:pt>
                <c:pt idx="2">
                  <c:v>101.09791681911942</c:v>
                </c:pt>
                <c:pt idx="3">
                  <c:v>107.98731959021318</c:v>
                </c:pt>
                <c:pt idx="4">
                  <c:v>78.71211211880734</c:v>
                </c:pt>
              </c:numCache>
            </c:numRef>
          </c:val>
        </c:ser>
        <c:ser>
          <c:idx val="5"/>
          <c:order val="5"/>
          <c:tx>
            <c:strRef>
              <c:f>'graph for publication'!$C$111</c:f>
              <c:strCache>
                <c:ptCount val="1"/>
                <c:pt idx="0">
                  <c:v>Echinenon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graph for publication'!$D$105:$H$105</c:f>
              <c:strCache>
                <c:ptCount val="5"/>
                <c:pt idx="0">
                  <c:v>p-Ø</c:v>
                </c:pt>
                <c:pt idx="1">
                  <c:v>pZ+W</c:v>
                </c:pt>
                <c:pt idx="2">
                  <c:v>pZ-s-W</c:v>
                </c:pt>
                <c:pt idx="3">
                  <c:v>pZ-m-W</c:v>
                </c:pt>
                <c:pt idx="4">
                  <c:v>pZ-lg-W</c:v>
                </c:pt>
              </c:strCache>
            </c:strRef>
          </c:cat>
          <c:val>
            <c:numRef>
              <c:f>'graph for publication'!$D$111:$H$111</c:f>
              <c:numCache>
                <c:formatCode>General</c:formatCode>
                <c:ptCount val="5"/>
                <c:pt idx="0">
                  <c:v>0</c:v>
                </c:pt>
                <c:pt idx="1">
                  <c:v>34.27268617987658</c:v>
                </c:pt>
                <c:pt idx="2">
                  <c:v>29.183216588178041</c:v>
                </c:pt>
                <c:pt idx="3">
                  <c:v>28.237105519262702</c:v>
                </c:pt>
                <c:pt idx="4">
                  <c:v>18.871411688317455</c:v>
                </c:pt>
              </c:numCache>
            </c:numRef>
          </c:val>
        </c:ser>
        <c:ser>
          <c:idx val="6"/>
          <c:order val="6"/>
          <c:tx>
            <c:strRef>
              <c:f>'graph for publication'!$C$112</c:f>
              <c:strCache>
                <c:ptCount val="1"/>
                <c:pt idx="0">
                  <c:v>β-Carotene</c:v>
                </c:pt>
              </c:strCache>
            </c:strRef>
          </c:tx>
          <c:spPr>
            <a:solidFill>
              <a:srgbClr val="FF9966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graph for publication'!$D$105:$H$105</c:f>
              <c:strCache>
                <c:ptCount val="5"/>
                <c:pt idx="0">
                  <c:v>p-Ø</c:v>
                </c:pt>
                <c:pt idx="1">
                  <c:v>pZ+W</c:v>
                </c:pt>
                <c:pt idx="2">
                  <c:v>pZ-s-W</c:v>
                </c:pt>
                <c:pt idx="3">
                  <c:v>pZ-m-W</c:v>
                </c:pt>
                <c:pt idx="4">
                  <c:v>pZ-lg-W</c:v>
                </c:pt>
              </c:strCache>
            </c:strRef>
          </c:cat>
          <c:val>
            <c:numRef>
              <c:f>'graph for publication'!$D$112:$H$112</c:f>
              <c:numCache>
                <c:formatCode>General</c:formatCode>
                <c:ptCount val="5"/>
                <c:pt idx="0">
                  <c:v>481.39184188354722</c:v>
                </c:pt>
                <c:pt idx="1">
                  <c:v>88.828006761382241</c:v>
                </c:pt>
                <c:pt idx="2">
                  <c:v>175.82551196373572</c:v>
                </c:pt>
                <c:pt idx="3">
                  <c:v>182.40656246371637</c:v>
                </c:pt>
                <c:pt idx="4">
                  <c:v>127.889180343180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480705272"/>
        <c:axId val="480701744"/>
      </c:barChart>
      <c:catAx>
        <c:axId val="480705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0701744"/>
        <c:crosses val="autoZero"/>
        <c:auto val="1"/>
        <c:lblAlgn val="ctr"/>
        <c:lblOffset val="100"/>
        <c:noMultiLvlLbl val="0"/>
      </c:catAx>
      <c:valAx>
        <c:axId val="4807017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0705272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74082354071797873"/>
          <c:y val="0.21501724652530976"/>
          <c:w val="0.22615320360863062"/>
          <c:h val="0.634196291253510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662A65-1C8D-4822-A2A7-FDDFCDF0CACE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EF3BED-AF83-419E-80C4-D66907F365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2468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EF3BED-AF83-419E-80C4-D66907F3653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297644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2351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855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8304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115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483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64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344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909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3128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329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4709805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2CC90-8CA9-4EDB-819E-149F2035B89B}" type="datetimeFigureOut">
              <a:rPr lang="en-GB" smtClean="0"/>
              <a:t>3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F31A2-B0B0-43E5-9ED7-B0E656A1BD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035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notesSlide" Target="../notesSlides/notesSlide1.xml"/>
   <Relationship Id="rId3" Type="http://schemas.openxmlformats.org/officeDocument/2006/relationships/chart" Target="../charts/chart1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700242" y="4948923"/>
            <a:ext cx="924254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otenoid composition of agro-infiltrated </a:t>
            </a:r>
            <a:r>
              <a:rPr lang="en-GB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. benthamiana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ves from the best ketocarotenoids plant producer. Carotenoid data originate from three leaves pooled from the best ketocarotenoids agro-infiltrated plant for each construct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.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The graph represents the carotenoid composition as a percentage of </a:t>
            </a:r>
            <a:r>
              <a:rPr lang="en-GB" sz="1600" dirty="0" smtClean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total carotenoids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Ø, empty vector;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+W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 &amp; W;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, Z &amp; W fusions with the small, medium and long linker.</a:t>
            </a:r>
            <a:endParaRPr lang="en-GB" sz="16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336501"/>
              </p:ext>
            </p:extLst>
          </p:nvPr>
        </p:nvGraphicFramePr>
        <p:xfrm>
          <a:off x="1223761" y="1052946"/>
          <a:ext cx="6617912" cy="3741318"/>
        </p:xfrm>
        <a:graphic>
          <a:graphicData uri="http://schemas.openxmlformats.org/drawingml/2006/chart">
            <c:chart xmlns:c="http://schemas.openxmlformats.org/drawingml/2006/chart" r:id="rId3"/>
          </a:graphicData>
        </a:graphic>
      </p:graphicFrame>
    </p:spTree>
    <p:extLst>
      <p:ext uri="{BB962C8B-B14F-4D97-AF65-F5344CB8AC3E}">
        <p14:creationId xmlns:p14="http://schemas.microsoft.com/office/powerpoint/2010/main" val="3536217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78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8-04-10T15:59:05Z</cp:lastPrinted>
</cp:coreProperties>
</file>